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574" y="1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8951F4-D71D-14B4-8110-633C52A53E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68A409-6112-FD84-5C67-FAD41AA5AF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26CFAC-574B-83C1-0EE1-5BF11807E7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7FF9BC-E313-9DE8-F43E-C135AEF4E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52B2D5-53BE-5EF9-4050-6B07D8B6B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7654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1D897F-CBEC-57F4-793F-3FF82950C3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426A71-68F1-92C4-40CB-CA8A326F7D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535BC6-A131-7533-F721-D677ECB98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90FBB4-5C13-ED74-F28C-04297B23A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7B10FF-44B0-87E8-CE81-022D64E5AB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7510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18C2F45-24F9-7415-B1A2-6F92BBC403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A6E77C-4AC9-58B5-4F6B-67DA0302F8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728678-1CAE-428C-48BC-4EFC34702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1C8807-07C1-E76C-5324-B82FC04EF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01B66B-A0CF-5016-A240-E18D987AE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9544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EEC2D-090C-A56E-D133-947DDD9604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4094F9-94A6-6756-EC2F-6A193D6392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E782D4-1F0B-7F5E-DF36-AA61DC0C4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40B524-BC57-B984-4634-FD00C50F6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668466-E4D5-BBB9-33A4-420A4C76E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0807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12CABF-A761-BC5A-0609-186AD458E3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C869D-80F7-AF2C-21A5-0D5A490F86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02B77E-CA88-4ECD-F1A4-86A136322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F46E1E-7D33-121A-3988-B4F3812B3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CA9699-8E54-AF15-4E10-20F11D650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060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A227FF-D829-8759-0CF3-5FEFA2F701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2B5610-4666-46E1-F0EF-1037AE9267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566CCD-AA84-07A8-E9BB-435D798D05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6A5FDC-28D1-6086-C3A6-C0DA338F4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6E40A9-BC06-B21F-2AD8-1389F446D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547E74-9620-E72E-F349-7ED9452A2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8645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80F480-3596-BF84-3026-F86E9C7E98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9EF799-332D-C53E-50A6-9C44284D85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949D39-01C2-ACC8-DFAE-09B29DD86C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B27F34-9095-004A-246D-90DA0FD4A6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5DE6261-C592-9210-898B-8F0D505E3E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FBE31B-81CD-8BB2-C0D6-A6CA60611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42C6E85-618F-8C73-E039-09F7DEE78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2C6483D-294F-BDCC-09BF-3969A5DA3E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0926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50C0E0-0975-AEB6-20DA-7C05E768D2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DA39FE-3073-D8A6-A669-726DF9A74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FA1DC7F-592D-C093-99AB-80513E902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52E981-02CD-9447-1536-85BBAF386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0129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AB6A78D-1AC1-F74B-F7DB-B2ACB39A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4346CE-69F8-59C5-E3C6-6C2318A04C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C1ECD6F-0981-745D-163D-2E93308D9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9343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0295BB-CA2D-C48B-7D40-32B16EF1E0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166A2E-3F04-6EFC-986C-E3C90814EE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DC2F24-1625-38D0-8957-0CF78A02AD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182C54-6CFD-547F-0C68-9F3816436B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538867-F8B9-4AC1-A92C-AB35F6289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5BD3FD-2D24-7F28-9A42-7CDB5E8AD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6251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4CACF0-A496-66C2-FC25-09D011DF30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4828D0-1DC6-2E84-63C1-A2E8C9594B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500274-665A-E1C5-A3A8-96E12AF5C6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91C822-3245-F7C3-A271-A0802461A0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80C1FF-404C-ABFD-5EA1-A9E1C03B9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356E14-31E6-3672-6918-59CFABB55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4636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E52C6F-7DFD-6DEF-114B-71888B5A9C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9D382E-6A14-5CC2-B15D-DEECD47807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8A9D62-1635-D61D-E2E9-D70AE96F9E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80B632-0ED5-4BFF-9E21-73D2C8FEED5B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22C34B-7E36-3972-D988-9D3DF5A114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96A31A-182E-00E1-EC95-3F667C9C82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56F94E-4C5C-4A0D-9136-9AF11C54DF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3320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eg"/><Relationship Id="rId7" Type="http://schemas.openxmlformats.org/officeDocument/2006/relationships/image" Target="../media/image6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jpeg"/><Relationship Id="rId7" Type="http://schemas.openxmlformats.org/officeDocument/2006/relationships/image" Target="../media/image13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g"/><Relationship Id="rId5" Type="http://schemas.openxmlformats.org/officeDocument/2006/relationships/image" Target="../media/image11.jpg"/><Relationship Id="rId4" Type="http://schemas.openxmlformats.org/officeDocument/2006/relationships/image" Target="../media/image10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jpg"/><Relationship Id="rId4" Type="http://schemas.openxmlformats.org/officeDocument/2006/relationships/image" Target="../media/image1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3091182-C706-BE83-A78D-61AE99D9EA3B}"/>
              </a:ext>
            </a:extLst>
          </p:cNvPr>
          <p:cNvSpPr txBox="1"/>
          <p:nvPr/>
        </p:nvSpPr>
        <p:spPr>
          <a:xfrm>
            <a:off x="122432" y="36573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A1A1390-CBE4-EA64-D03E-8BE288703AD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68" t="15602" r="58945" b="55675"/>
          <a:stretch/>
        </p:blipFill>
        <p:spPr>
          <a:xfrm rot="5400000">
            <a:off x="1189185" y="2639665"/>
            <a:ext cx="369475" cy="14778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ED77950-6098-D45C-E82A-D13B6440B745}"/>
              </a:ext>
            </a:extLst>
          </p:cNvPr>
          <p:cNvSpPr txBox="1"/>
          <p:nvPr/>
        </p:nvSpPr>
        <p:spPr>
          <a:xfrm>
            <a:off x="2103067" y="3321349"/>
            <a:ext cx="44767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5F2242E-CCC4-8078-6DD2-D6DE6A60A2F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341" t="9987" r="13086" b="61398"/>
          <a:stretch/>
        </p:blipFill>
        <p:spPr>
          <a:xfrm rot="16200000">
            <a:off x="1189185" y="589743"/>
            <a:ext cx="369475" cy="14778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5E7AC59-8F97-F7E2-A6E7-0D6EAE9D1B4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071" t="10035" r="28395" b="61255"/>
          <a:stretch/>
        </p:blipFill>
        <p:spPr>
          <a:xfrm rot="16200000">
            <a:off x="1189185" y="3049651"/>
            <a:ext cx="369475" cy="14778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6E389C0-8487-49B8-ADE7-671787E2336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615" t="52419" r="21072" b="19607"/>
          <a:stretch/>
        </p:blipFill>
        <p:spPr>
          <a:xfrm rot="16200000">
            <a:off x="1189185" y="999727"/>
            <a:ext cx="369475" cy="14778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5BC99B0-D62C-5177-D6BA-938C9D5BCB8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698" t="54068" r="29989" b="17958"/>
          <a:stretch/>
        </p:blipFill>
        <p:spPr>
          <a:xfrm rot="16200000">
            <a:off x="1189185" y="2229680"/>
            <a:ext cx="369475" cy="14778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4EDF989-5282-D68F-57D5-C788D2BE5EA8}"/>
              </a:ext>
            </a:extLst>
          </p:cNvPr>
          <p:cNvSpPr txBox="1"/>
          <p:nvPr/>
        </p:nvSpPr>
        <p:spPr>
          <a:xfrm rot="18000000">
            <a:off x="580089" y="85360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6E8BA47-FC2F-35E1-6377-44BE38BEEADB}"/>
              </a:ext>
            </a:extLst>
          </p:cNvPr>
          <p:cNvSpPr txBox="1"/>
          <p:nvPr/>
        </p:nvSpPr>
        <p:spPr>
          <a:xfrm rot="18000000">
            <a:off x="715299" y="775010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DE1AE19-9E4D-1852-B88F-A5D87660F2E8}"/>
              </a:ext>
            </a:extLst>
          </p:cNvPr>
          <p:cNvSpPr txBox="1"/>
          <p:nvPr/>
        </p:nvSpPr>
        <p:spPr>
          <a:xfrm rot="18000000">
            <a:off x="917014" y="818192"/>
            <a:ext cx="447676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F632765-0EFE-EACC-530F-EA3E54EFEFA6}"/>
              </a:ext>
            </a:extLst>
          </p:cNvPr>
          <p:cNvSpPr txBox="1"/>
          <p:nvPr/>
        </p:nvSpPr>
        <p:spPr>
          <a:xfrm rot="18000000">
            <a:off x="1066107" y="801094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BA59780-35DF-FBE5-4DC7-D50E6924931C}"/>
              </a:ext>
            </a:extLst>
          </p:cNvPr>
          <p:cNvSpPr txBox="1"/>
          <p:nvPr/>
        </p:nvSpPr>
        <p:spPr>
          <a:xfrm>
            <a:off x="702049" y="434521"/>
            <a:ext cx="712948" cy="209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F2BA9DC2-DE00-CBB1-54B8-88CE51CED62E}"/>
              </a:ext>
            </a:extLst>
          </p:cNvPr>
          <p:cNvCxnSpPr>
            <a:cxnSpLocks/>
          </p:cNvCxnSpPr>
          <p:nvPr/>
        </p:nvCxnSpPr>
        <p:spPr>
          <a:xfrm flipV="1">
            <a:off x="676947" y="645227"/>
            <a:ext cx="649345" cy="199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55E84DA8-5F7E-D5F4-53B1-B6F294522671}"/>
              </a:ext>
            </a:extLst>
          </p:cNvPr>
          <p:cNvSpPr txBox="1"/>
          <p:nvPr/>
        </p:nvSpPr>
        <p:spPr>
          <a:xfrm>
            <a:off x="1507959" y="436993"/>
            <a:ext cx="844002" cy="209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D3E967B-1578-825E-28E7-1B7C1CC90BB3}"/>
              </a:ext>
            </a:extLst>
          </p:cNvPr>
          <p:cNvSpPr txBox="1"/>
          <p:nvPr/>
        </p:nvSpPr>
        <p:spPr>
          <a:xfrm>
            <a:off x="233289" y="714847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26748DD-449D-0EC6-DE48-0F6673D31976}"/>
              </a:ext>
            </a:extLst>
          </p:cNvPr>
          <p:cNvSpPr txBox="1"/>
          <p:nvPr/>
        </p:nvSpPr>
        <p:spPr>
          <a:xfrm rot="18000000">
            <a:off x="1297108" y="88333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A3269D2-1B53-9836-391E-6D1978FB9C87}"/>
              </a:ext>
            </a:extLst>
          </p:cNvPr>
          <p:cNvSpPr txBox="1"/>
          <p:nvPr/>
        </p:nvSpPr>
        <p:spPr>
          <a:xfrm rot="18000000">
            <a:off x="1416594" y="775010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AEA6197-41B8-9862-26A6-56040AB82CEE}"/>
              </a:ext>
            </a:extLst>
          </p:cNvPr>
          <p:cNvSpPr txBox="1"/>
          <p:nvPr/>
        </p:nvSpPr>
        <p:spPr>
          <a:xfrm rot="18000000">
            <a:off x="1618308" y="818192"/>
            <a:ext cx="447676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4372066-E79D-6EBC-74D3-703DDD25BF1F}"/>
              </a:ext>
            </a:extLst>
          </p:cNvPr>
          <p:cNvSpPr txBox="1"/>
          <p:nvPr/>
        </p:nvSpPr>
        <p:spPr>
          <a:xfrm rot="18000000">
            <a:off x="1767401" y="801094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4A5AD042-D830-7E10-7198-41AA65D92C08}"/>
              </a:ext>
            </a:extLst>
          </p:cNvPr>
          <p:cNvCxnSpPr>
            <a:cxnSpLocks/>
          </p:cNvCxnSpPr>
          <p:nvPr/>
        </p:nvCxnSpPr>
        <p:spPr>
          <a:xfrm flipV="1">
            <a:off x="1462235" y="645226"/>
            <a:ext cx="649345" cy="199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DB2BD512-55E6-153A-5CF4-EF02D230EDF8}"/>
              </a:ext>
            </a:extLst>
          </p:cNvPr>
          <p:cNvSpPr txBox="1"/>
          <p:nvPr/>
        </p:nvSpPr>
        <p:spPr>
          <a:xfrm>
            <a:off x="513221" y="3977201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D051C82-EA75-7281-50BD-ED004E8C16DC}"/>
              </a:ext>
            </a:extLst>
          </p:cNvPr>
          <p:cNvSpPr txBox="1"/>
          <p:nvPr/>
        </p:nvSpPr>
        <p:spPr>
          <a:xfrm>
            <a:off x="2103067" y="1290942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69001A9-F758-5D53-91F2-06D64CB69C45}"/>
              </a:ext>
            </a:extLst>
          </p:cNvPr>
          <p:cNvSpPr txBox="1"/>
          <p:nvPr/>
        </p:nvSpPr>
        <p:spPr>
          <a:xfrm>
            <a:off x="2103067" y="1687614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7FB8F6E-9B01-41D7-A917-8C317141715E}"/>
              </a:ext>
            </a:extLst>
          </p:cNvPr>
          <p:cNvSpPr txBox="1"/>
          <p:nvPr/>
        </p:nvSpPr>
        <p:spPr>
          <a:xfrm>
            <a:off x="2103067" y="2877628"/>
            <a:ext cx="371896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ACFD074-7C07-93EE-652D-D865CA216E22}"/>
              </a:ext>
            </a:extLst>
          </p:cNvPr>
          <p:cNvSpPr txBox="1"/>
          <p:nvPr/>
        </p:nvSpPr>
        <p:spPr>
          <a:xfrm>
            <a:off x="2103067" y="3718021"/>
            <a:ext cx="49576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B9D774CB-948A-C4FF-7376-F15F6CFE1AF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48" t="18751" r="73089" b="54060"/>
          <a:stretch/>
        </p:blipFill>
        <p:spPr>
          <a:xfrm rot="5400000">
            <a:off x="1189185" y="1409712"/>
            <a:ext cx="369475" cy="14778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00679984-2E96-5694-4AC6-C129B719F7B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22" t="56876" r="64079" b="15444"/>
          <a:stretch/>
        </p:blipFill>
        <p:spPr>
          <a:xfrm rot="5400000">
            <a:off x="1188217" y="1820018"/>
            <a:ext cx="368827" cy="14778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30FE445D-4762-C67E-2584-20B15EA203BD}"/>
              </a:ext>
            </a:extLst>
          </p:cNvPr>
          <p:cNvSpPr txBox="1"/>
          <p:nvPr/>
        </p:nvSpPr>
        <p:spPr>
          <a:xfrm>
            <a:off x="2103067" y="2084284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D9DC62B-D367-8ABB-2D58-F5448B713D64}"/>
              </a:ext>
            </a:extLst>
          </p:cNvPr>
          <p:cNvSpPr txBox="1"/>
          <p:nvPr/>
        </p:nvSpPr>
        <p:spPr>
          <a:xfrm>
            <a:off x="2103067" y="2480956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A839A94-1AE0-175F-73D7-A761D801C89F}"/>
              </a:ext>
            </a:extLst>
          </p:cNvPr>
          <p:cNvSpPr txBox="1"/>
          <p:nvPr/>
        </p:nvSpPr>
        <p:spPr>
          <a:xfrm>
            <a:off x="233289" y="905694"/>
            <a:ext cx="35440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CD04707-CD21-B2EC-39D3-393C6FD7353A}"/>
              </a:ext>
            </a:extLst>
          </p:cNvPr>
          <p:cNvSpPr txBox="1"/>
          <p:nvPr/>
        </p:nvSpPr>
        <p:spPr>
          <a:xfrm>
            <a:off x="249833" y="1183431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2221EC9-4DFE-87FF-B8DA-89A17871986C}"/>
              </a:ext>
            </a:extLst>
          </p:cNvPr>
          <p:cNvSpPr txBox="1"/>
          <p:nvPr/>
        </p:nvSpPr>
        <p:spPr>
          <a:xfrm>
            <a:off x="298008" y="1649382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27D8DE0-E617-7BC5-F959-98F69BCAC824}"/>
              </a:ext>
            </a:extLst>
          </p:cNvPr>
          <p:cNvSpPr txBox="1"/>
          <p:nvPr/>
        </p:nvSpPr>
        <p:spPr>
          <a:xfrm>
            <a:off x="298008" y="2976179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38FEDFC-5604-1CDE-77A7-1E809B0E0F4B}"/>
              </a:ext>
            </a:extLst>
          </p:cNvPr>
          <p:cNvSpPr txBox="1"/>
          <p:nvPr/>
        </p:nvSpPr>
        <p:spPr>
          <a:xfrm>
            <a:off x="298008" y="3786031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A77C11B-3188-E1A3-17FF-260579C4930A}"/>
              </a:ext>
            </a:extLst>
          </p:cNvPr>
          <p:cNvSpPr txBox="1"/>
          <p:nvPr/>
        </p:nvSpPr>
        <p:spPr>
          <a:xfrm>
            <a:off x="298008" y="2005557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36487A0-E666-D7A2-8BB0-9B47B3771B68}"/>
              </a:ext>
            </a:extLst>
          </p:cNvPr>
          <p:cNvSpPr txBox="1"/>
          <p:nvPr/>
        </p:nvSpPr>
        <p:spPr>
          <a:xfrm>
            <a:off x="298008" y="2333718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4621058-E14C-6023-957F-CBD89164152E}"/>
              </a:ext>
            </a:extLst>
          </p:cNvPr>
          <p:cNvSpPr txBox="1"/>
          <p:nvPr/>
        </p:nvSpPr>
        <p:spPr>
          <a:xfrm>
            <a:off x="298008" y="3381307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493E778-5A13-BD70-2066-959D9C8EB009}"/>
              </a:ext>
            </a:extLst>
          </p:cNvPr>
          <p:cNvSpPr txBox="1"/>
          <p:nvPr/>
        </p:nvSpPr>
        <p:spPr>
          <a:xfrm>
            <a:off x="298008" y="3568267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DA0EC0B-2C85-2694-7A24-36548764B3D4}"/>
              </a:ext>
            </a:extLst>
          </p:cNvPr>
          <p:cNvCxnSpPr/>
          <p:nvPr/>
        </p:nvCxnSpPr>
        <p:spPr>
          <a:xfrm>
            <a:off x="551288" y="1301059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A0B78A71-9048-27FF-8058-9CEFEE103736}"/>
              </a:ext>
            </a:extLst>
          </p:cNvPr>
          <p:cNvCxnSpPr/>
          <p:nvPr/>
        </p:nvCxnSpPr>
        <p:spPr>
          <a:xfrm>
            <a:off x="551288" y="175970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9B66420E-A372-F1AA-7E3F-FDB89CEDCA51}"/>
              </a:ext>
            </a:extLst>
          </p:cNvPr>
          <p:cNvCxnSpPr/>
          <p:nvPr/>
        </p:nvCxnSpPr>
        <p:spPr>
          <a:xfrm>
            <a:off x="551288" y="211692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045D52A0-378B-CC08-A469-13EB39BBAAF9}"/>
              </a:ext>
            </a:extLst>
          </p:cNvPr>
          <p:cNvCxnSpPr/>
          <p:nvPr/>
        </p:nvCxnSpPr>
        <p:spPr>
          <a:xfrm>
            <a:off x="551288" y="245347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E3E1A5FA-23DA-14EC-A14E-7232A734582B}"/>
              </a:ext>
            </a:extLst>
          </p:cNvPr>
          <p:cNvCxnSpPr/>
          <p:nvPr/>
        </p:nvCxnSpPr>
        <p:spPr>
          <a:xfrm>
            <a:off x="551288" y="308847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9557CE0F-8434-BF04-0B4F-61819C451881}"/>
              </a:ext>
            </a:extLst>
          </p:cNvPr>
          <p:cNvCxnSpPr/>
          <p:nvPr/>
        </p:nvCxnSpPr>
        <p:spPr>
          <a:xfrm>
            <a:off x="551288" y="349487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F9C55D50-B0F1-1011-4EEB-A1DA8992A6B5}"/>
              </a:ext>
            </a:extLst>
          </p:cNvPr>
          <p:cNvCxnSpPr/>
          <p:nvPr/>
        </p:nvCxnSpPr>
        <p:spPr>
          <a:xfrm>
            <a:off x="551288" y="390762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F89F1325-21AB-833E-7FB5-8F8999E9208B}"/>
              </a:ext>
            </a:extLst>
          </p:cNvPr>
          <p:cNvCxnSpPr/>
          <p:nvPr/>
        </p:nvCxnSpPr>
        <p:spPr>
          <a:xfrm>
            <a:off x="555766" y="368059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0" name="Picture 49">
            <a:extLst>
              <a:ext uri="{FF2B5EF4-FFF2-40B4-BE49-F238E27FC236}">
                <a16:creationId xmlns:a16="http://schemas.microsoft.com/office/drawing/2014/main" id="{2A55A10B-1641-3289-2A21-27A16629A65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9" t="267" r="742" b="90"/>
          <a:stretch/>
        </p:blipFill>
        <p:spPr>
          <a:xfrm rot="16200000">
            <a:off x="3482618" y="-324082"/>
            <a:ext cx="1940079" cy="29049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F62C1EC1-E5F9-F437-EB78-9E0DAFBD333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0" t="594" r="199" b="174"/>
          <a:stretch/>
        </p:blipFill>
        <p:spPr>
          <a:xfrm rot="16200000">
            <a:off x="6480525" y="-351240"/>
            <a:ext cx="2019586" cy="29592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4048D49-FFB8-B86B-ABF2-64FB01E7B57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" t="-414" r="676" b="-1362"/>
          <a:stretch/>
        </p:blipFill>
        <p:spPr>
          <a:xfrm rot="5400000">
            <a:off x="9152856" y="-84789"/>
            <a:ext cx="2773805" cy="31227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0B2FD8D4-C4FD-EDB4-BAC0-813B42B5997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15" t="661" r="1419" b="722"/>
          <a:stretch/>
        </p:blipFill>
        <p:spPr>
          <a:xfrm rot="5400000">
            <a:off x="2842607" y="2299933"/>
            <a:ext cx="3220099" cy="29721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DE920AD8-4B01-CEC4-2E1F-E27B8FE458F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" t="653" r="-350" b="437"/>
          <a:stretch/>
        </p:blipFill>
        <p:spPr>
          <a:xfrm rot="16200000">
            <a:off x="6388953" y="1838082"/>
            <a:ext cx="2247375" cy="2949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D0A42F5F-8769-B87C-E876-E28A929DDA8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2" t="509" r="-906" b="89"/>
          <a:stretch/>
        </p:blipFill>
        <p:spPr>
          <a:xfrm rot="5400000">
            <a:off x="6441905" y="4099560"/>
            <a:ext cx="2110963" cy="28870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9C47765D-E2EA-C809-D009-FE79FF4ADCE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3" t="528" r="-264" b="309"/>
          <a:stretch/>
        </p:blipFill>
        <p:spPr>
          <a:xfrm rot="16200000">
            <a:off x="9554475" y="4172571"/>
            <a:ext cx="1970566" cy="2881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5" name="Rectangle 54">
            <a:extLst>
              <a:ext uri="{FF2B5EF4-FFF2-40B4-BE49-F238E27FC236}">
                <a16:creationId xmlns:a16="http://schemas.microsoft.com/office/drawing/2014/main" id="{CB0FA5D4-780C-B25F-4BC7-302DEF59F58A}"/>
              </a:ext>
            </a:extLst>
          </p:cNvPr>
          <p:cNvSpPr/>
          <p:nvPr/>
        </p:nvSpPr>
        <p:spPr>
          <a:xfrm>
            <a:off x="3253740" y="365737"/>
            <a:ext cx="822960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B8FA5C30-0334-51F5-2E2D-06CD05C6E791}"/>
              </a:ext>
            </a:extLst>
          </p:cNvPr>
          <p:cNvSpPr/>
          <p:nvPr/>
        </p:nvSpPr>
        <p:spPr>
          <a:xfrm>
            <a:off x="7574524" y="464571"/>
            <a:ext cx="822960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B895DBBB-EF8A-229E-9A9C-821CF6F902F6}"/>
              </a:ext>
            </a:extLst>
          </p:cNvPr>
          <p:cNvSpPr/>
          <p:nvPr/>
        </p:nvSpPr>
        <p:spPr>
          <a:xfrm>
            <a:off x="10709635" y="569494"/>
            <a:ext cx="822960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17DD8DB7-8DE2-3890-9738-2D22869CDA71}"/>
              </a:ext>
            </a:extLst>
          </p:cNvPr>
          <p:cNvSpPr/>
          <p:nvPr/>
        </p:nvSpPr>
        <p:spPr>
          <a:xfrm>
            <a:off x="3404430" y="3093089"/>
            <a:ext cx="822960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6C265A84-712E-1B16-F693-6FD4CF7BA6EE}"/>
              </a:ext>
            </a:extLst>
          </p:cNvPr>
          <p:cNvSpPr/>
          <p:nvPr/>
        </p:nvSpPr>
        <p:spPr>
          <a:xfrm>
            <a:off x="7638579" y="2864858"/>
            <a:ext cx="822960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DBFAF242-3C25-E034-C950-E5F41F296AD5}"/>
              </a:ext>
            </a:extLst>
          </p:cNvPr>
          <p:cNvSpPr/>
          <p:nvPr/>
        </p:nvSpPr>
        <p:spPr>
          <a:xfrm>
            <a:off x="7668817" y="5110596"/>
            <a:ext cx="822960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DF253E5B-3A68-7CC4-0203-75890366C7E1}"/>
              </a:ext>
            </a:extLst>
          </p:cNvPr>
          <p:cNvSpPr/>
          <p:nvPr/>
        </p:nvSpPr>
        <p:spPr>
          <a:xfrm>
            <a:off x="9429037" y="5941176"/>
            <a:ext cx="822960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A3F0D27-BEFF-175A-348C-B69D53D81525}"/>
              </a:ext>
            </a:extLst>
          </p:cNvPr>
          <p:cNvSpPr txBox="1"/>
          <p:nvPr/>
        </p:nvSpPr>
        <p:spPr>
          <a:xfrm>
            <a:off x="4052499" y="385951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D218362-3A32-1236-0E47-8017BCBF6345}"/>
              </a:ext>
            </a:extLst>
          </p:cNvPr>
          <p:cNvSpPr txBox="1"/>
          <p:nvPr/>
        </p:nvSpPr>
        <p:spPr>
          <a:xfrm>
            <a:off x="8422940" y="482177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0421F30-9FA3-3E2D-150A-EED7D933E1A0}"/>
              </a:ext>
            </a:extLst>
          </p:cNvPr>
          <p:cNvSpPr txBox="1"/>
          <p:nvPr/>
        </p:nvSpPr>
        <p:spPr>
          <a:xfrm>
            <a:off x="11558051" y="428516"/>
            <a:ext cx="491394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830CBB0-C986-60A6-DB1B-04376F4C58A6}"/>
              </a:ext>
            </a:extLst>
          </p:cNvPr>
          <p:cNvSpPr txBox="1"/>
          <p:nvPr/>
        </p:nvSpPr>
        <p:spPr>
          <a:xfrm>
            <a:off x="4205026" y="3102811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FC215A2-C6E2-D54D-B2C3-308438D17E24}"/>
              </a:ext>
            </a:extLst>
          </p:cNvPr>
          <p:cNvSpPr txBox="1"/>
          <p:nvPr/>
        </p:nvSpPr>
        <p:spPr>
          <a:xfrm>
            <a:off x="8464106" y="2871255"/>
            <a:ext cx="371896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7A09D45-6127-E815-07F4-B9C7C2B29C19}"/>
              </a:ext>
            </a:extLst>
          </p:cNvPr>
          <p:cNvSpPr txBox="1"/>
          <p:nvPr/>
        </p:nvSpPr>
        <p:spPr>
          <a:xfrm>
            <a:off x="8497860" y="5118630"/>
            <a:ext cx="44767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25A8E7D-742D-ACF3-CAFA-AFFE1FDC5B2F}"/>
              </a:ext>
            </a:extLst>
          </p:cNvPr>
          <p:cNvSpPr txBox="1"/>
          <p:nvPr/>
        </p:nvSpPr>
        <p:spPr>
          <a:xfrm>
            <a:off x="10271236" y="5941176"/>
            <a:ext cx="49576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3740438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D6EF373-D6CD-FFC2-8A0E-220F8D800DA4}"/>
              </a:ext>
            </a:extLst>
          </p:cNvPr>
          <p:cNvSpPr txBox="1"/>
          <p:nvPr/>
        </p:nvSpPr>
        <p:spPr>
          <a:xfrm>
            <a:off x="153855" y="9903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91D7614-1404-F2EE-8983-1E0ACEE6B22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541" t="49201" r="33363" b="24107"/>
          <a:stretch/>
        </p:blipFill>
        <p:spPr>
          <a:xfrm rot="16200000">
            <a:off x="1236427" y="1843113"/>
            <a:ext cx="368827" cy="17067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EBA458E-E372-E596-6B14-F1175A23816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08" t="50000" r="64742" b="22738"/>
          <a:stretch/>
        </p:blipFill>
        <p:spPr>
          <a:xfrm rot="16200000">
            <a:off x="1234703" y="2254822"/>
            <a:ext cx="372276" cy="17067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90CAAD4-AB57-03DF-6FAE-BE9ABCADAC2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36" t="49315" r="51961" b="23054"/>
          <a:stretch/>
        </p:blipFill>
        <p:spPr>
          <a:xfrm rot="16200000">
            <a:off x="1257423" y="224816"/>
            <a:ext cx="326837" cy="17067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6E958E7-4BCF-1516-0C06-80CAA83AB5E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036" t="49543" r="24275" b="21215"/>
          <a:stretch/>
        </p:blipFill>
        <p:spPr>
          <a:xfrm rot="16200000">
            <a:off x="1236103" y="1023469"/>
            <a:ext cx="369474" cy="17067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CB4B893-3504-7017-1CDF-425ED0C0502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78" t="47266" r="59534" b="24713"/>
          <a:stretch/>
        </p:blipFill>
        <p:spPr>
          <a:xfrm rot="16200000">
            <a:off x="1236427" y="1433774"/>
            <a:ext cx="368826" cy="17067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BBC58ED-6234-9F7D-D753-C0962B3E9E7E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28" t="49772" r="68835" b="21296"/>
          <a:stretch/>
        </p:blipFill>
        <p:spPr>
          <a:xfrm rot="16200000">
            <a:off x="1234703" y="2662009"/>
            <a:ext cx="372276" cy="17067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12FA79D-9713-F138-263B-BD5CED7ADB35}"/>
              </a:ext>
            </a:extLst>
          </p:cNvPr>
          <p:cNvSpPr txBox="1"/>
          <p:nvPr/>
        </p:nvSpPr>
        <p:spPr>
          <a:xfrm rot="18000000">
            <a:off x="866878" y="535078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D246EFC-B153-A4BF-351D-1EF7DB8769A4}"/>
              </a:ext>
            </a:extLst>
          </p:cNvPr>
          <p:cNvSpPr txBox="1"/>
          <p:nvPr/>
        </p:nvSpPr>
        <p:spPr>
          <a:xfrm rot="18000000">
            <a:off x="752315" y="556965"/>
            <a:ext cx="44767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D36E763-542E-2F55-CADF-FE8EABB92356}"/>
              </a:ext>
            </a:extLst>
          </p:cNvPr>
          <p:cNvSpPr txBox="1"/>
          <p:nvPr/>
        </p:nvSpPr>
        <p:spPr>
          <a:xfrm rot="18000000">
            <a:off x="605236" y="518612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8CF61AD-1D20-80E7-DADE-96AF56E51E7B}"/>
              </a:ext>
            </a:extLst>
          </p:cNvPr>
          <p:cNvSpPr txBox="1"/>
          <p:nvPr/>
        </p:nvSpPr>
        <p:spPr>
          <a:xfrm rot="18000000">
            <a:off x="505103" y="63569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A10E245-F2B9-F91F-5AF6-EFAC017B3569}"/>
              </a:ext>
            </a:extLst>
          </p:cNvPr>
          <p:cNvSpPr txBox="1"/>
          <p:nvPr/>
        </p:nvSpPr>
        <p:spPr>
          <a:xfrm rot="18000000">
            <a:off x="1409965" y="535078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E7FFB4C-6D14-3CFD-A355-4D14E7A51EC3}"/>
              </a:ext>
            </a:extLst>
          </p:cNvPr>
          <p:cNvSpPr txBox="1"/>
          <p:nvPr/>
        </p:nvSpPr>
        <p:spPr>
          <a:xfrm rot="18000000">
            <a:off x="1300422" y="551941"/>
            <a:ext cx="44767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B35AB26-2B02-1D17-DBA3-83BE46131E91}"/>
              </a:ext>
            </a:extLst>
          </p:cNvPr>
          <p:cNvSpPr txBox="1"/>
          <p:nvPr/>
        </p:nvSpPr>
        <p:spPr>
          <a:xfrm rot="18000000">
            <a:off x="1153333" y="524540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A2ED1F3-6B71-E24E-0E00-3B5D63EFBEE5}"/>
              </a:ext>
            </a:extLst>
          </p:cNvPr>
          <p:cNvSpPr txBox="1"/>
          <p:nvPr/>
        </p:nvSpPr>
        <p:spPr>
          <a:xfrm rot="18000000">
            <a:off x="1056346" y="62955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5C2FB4E-524C-43D9-B773-820EB2EBA3D7}"/>
              </a:ext>
            </a:extLst>
          </p:cNvPr>
          <p:cNvSpPr txBox="1"/>
          <p:nvPr/>
        </p:nvSpPr>
        <p:spPr>
          <a:xfrm rot="18000000">
            <a:off x="1993243" y="550150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92C3206-9509-8C7A-35A3-06EC3EA59883}"/>
              </a:ext>
            </a:extLst>
          </p:cNvPr>
          <p:cNvSpPr txBox="1"/>
          <p:nvPr/>
        </p:nvSpPr>
        <p:spPr>
          <a:xfrm rot="18000000">
            <a:off x="1836197" y="541449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34CF235-4BFA-6118-6EF1-4BE86546C8E2}"/>
              </a:ext>
            </a:extLst>
          </p:cNvPr>
          <p:cNvSpPr txBox="1"/>
          <p:nvPr/>
        </p:nvSpPr>
        <p:spPr>
          <a:xfrm rot="18000000">
            <a:off x="1701442" y="514492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0B67148-A698-48F5-A200-F9F2BDF215DD}"/>
              </a:ext>
            </a:extLst>
          </p:cNvPr>
          <p:cNvSpPr txBox="1"/>
          <p:nvPr/>
        </p:nvSpPr>
        <p:spPr>
          <a:xfrm rot="18000000">
            <a:off x="1595644" y="62537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0F29811-58AD-0E35-ECE4-5FFFFD491FA6}"/>
              </a:ext>
            </a:extLst>
          </p:cNvPr>
          <p:cNvSpPr txBox="1"/>
          <p:nvPr/>
        </p:nvSpPr>
        <p:spPr>
          <a:xfrm>
            <a:off x="157371" y="443054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3E1AD61-6DB4-7532-9E34-E442CA1E482E}"/>
              </a:ext>
            </a:extLst>
          </p:cNvPr>
          <p:cNvSpPr txBox="1"/>
          <p:nvPr/>
        </p:nvSpPr>
        <p:spPr>
          <a:xfrm>
            <a:off x="580336" y="159956"/>
            <a:ext cx="556971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4FB60B5-12F6-F7C6-376F-4D00B22FDCE2}"/>
              </a:ext>
            </a:extLst>
          </p:cNvPr>
          <p:cNvSpPr txBox="1"/>
          <p:nvPr/>
        </p:nvSpPr>
        <p:spPr>
          <a:xfrm>
            <a:off x="1686073" y="159956"/>
            <a:ext cx="49868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DDAC582-5D49-626C-5B55-9F9D9D29A0A2}"/>
              </a:ext>
            </a:extLst>
          </p:cNvPr>
          <p:cNvSpPr txBox="1"/>
          <p:nvPr/>
        </p:nvSpPr>
        <p:spPr>
          <a:xfrm>
            <a:off x="1162676" y="159956"/>
            <a:ext cx="494308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DMO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C8E5EC4-3033-6763-9825-3D7044464213}"/>
              </a:ext>
            </a:extLst>
          </p:cNvPr>
          <p:cNvSpPr txBox="1"/>
          <p:nvPr/>
        </p:nvSpPr>
        <p:spPr>
          <a:xfrm>
            <a:off x="474497" y="3705408"/>
            <a:ext cx="7168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549 cells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E9B4E1A-BA1B-60DF-B1CD-2801976FEACB}"/>
              </a:ext>
            </a:extLst>
          </p:cNvPr>
          <p:cNvCxnSpPr>
            <a:cxnSpLocks/>
          </p:cNvCxnSpPr>
          <p:nvPr/>
        </p:nvCxnSpPr>
        <p:spPr>
          <a:xfrm>
            <a:off x="621784" y="365573"/>
            <a:ext cx="52142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7F51BE67-9B7B-F583-1B27-B2C744980448}"/>
              </a:ext>
            </a:extLst>
          </p:cNvPr>
          <p:cNvCxnSpPr>
            <a:cxnSpLocks/>
          </p:cNvCxnSpPr>
          <p:nvPr/>
        </p:nvCxnSpPr>
        <p:spPr>
          <a:xfrm>
            <a:off x="1164869" y="365380"/>
            <a:ext cx="52142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F1814622-23AF-E5B0-5FF4-1CCA2DCDD3F1}"/>
              </a:ext>
            </a:extLst>
          </p:cNvPr>
          <p:cNvCxnSpPr>
            <a:cxnSpLocks/>
          </p:cNvCxnSpPr>
          <p:nvPr/>
        </p:nvCxnSpPr>
        <p:spPr>
          <a:xfrm>
            <a:off x="1707955" y="365573"/>
            <a:ext cx="52142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76181693-3FB1-4E22-FA12-5F911777C8B3}"/>
              </a:ext>
            </a:extLst>
          </p:cNvPr>
          <p:cNvSpPr txBox="1"/>
          <p:nvPr/>
        </p:nvSpPr>
        <p:spPr>
          <a:xfrm>
            <a:off x="2274951" y="3049557"/>
            <a:ext cx="44767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21E0581-06FD-BA63-1508-E1B41AD9D2DF}"/>
              </a:ext>
            </a:extLst>
          </p:cNvPr>
          <p:cNvSpPr txBox="1"/>
          <p:nvPr/>
        </p:nvSpPr>
        <p:spPr>
          <a:xfrm>
            <a:off x="2274951" y="1019148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5C7BF61-6045-7EA3-8B00-9967E1326150}"/>
              </a:ext>
            </a:extLst>
          </p:cNvPr>
          <p:cNvSpPr txBox="1"/>
          <p:nvPr/>
        </p:nvSpPr>
        <p:spPr>
          <a:xfrm>
            <a:off x="2274951" y="1415819"/>
            <a:ext cx="491393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3019029-7E28-FF27-22BB-7F48DCBA99B1}"/>
              </a:ext>
            </a:extLst>
          </p:cNvPr>
          <p:cNvSpPr txBox="1"/>
          <p:nvPr/>
        </p:nvSpPr>
        <p:spPr>
          <a:xfrm>
            <a:off x="2274951" y="2605835"/>
            <a:ext cx="37189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881E4EB-C8A0-CDA8-8AB0-2B073520FB93}"/>
              </a:ext>
            </a:extLst>
          </p:cNvPr>
          <p:cNvSpPr txBox="1"/>
          <p:nvPr/>
        </p:nvSpPr>
        <p:spPr>
          <a:xfrm>
            <a:off x="2274951" y="3446229"/>
            <a:ext cx="49576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EE697FF-27D4-2DD7-1E48-A0A99D500694}"/>
              </a:ext>
            </a:extLst>
          </p:cNvPr>
          <p:cNvSpPr txBox="1"/>
          <p:nvPr/>
        </p:nvSpPr>
        <p:spPr>
          <a:xfrm>
            <a:off x="2274951" y="1812491"/>
            <a:ext cx="491393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F13680E-3D53-8864-4DD5-47B5BC114EC8}"/>
              </a:ext>
            </a:extLst>
          </p:cNvPr>
          <p:cNvSpPr txBox="1"/>
          <p:nvPr/>
        </p:nvSpPr>
        <p:spPr>
          <a:xfrm>
            <a:off x="2274951" y="2209163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0ED2F56-7779-0F2F-F7D2-F7598B19A57C}"/>
              </a:ext>
            </a:extLst>
          </p:cNvPr>
          <p:cNvSpPr txBox="1"/>
          <p:nvPr/>
        </p:nvSpPr>
        <p:spPr>
          <a:xfrm>
            <a:off x="157371" y="633824"/>
            <a:ext cx="354409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B407C9C-B05B-4907-F365-35E79DC90DAC}"/>
              </a:ext>
            </a:extLst>
          </p:cNvPr>
          <p:cNvSpPr txBox="1"/>
          <p:nvPr/>
        </p:nvSpPr>
        <p:spPr>
          <a:xfrm>
            <a:off x="184408" y="859263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E4D4732-5835-04E3-B1A9-B83439A748AB}"/>
              </a:ext>
            </a:extLst>
          </p:cNvPr>
          <p:cNvSpPr txBox="1"/>
          <p:nvPr/>
        </p:nvSpPr>
        <p:spPr>
          <a:xfrm>
            <a:off x="232583" y="1325214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356E7CA-ACFC-3B43-1808-866C76281567}"/>
              </a:ext>
            </a:extLst>
          </p:cNvPr>
          <p:cNvSpPr txBox="1"/>
          <p:nvPr/>
        </p:nvSpPr>
        <p:spPr>
          <a:xfrm>
            <a:off x="232583" y="2690111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3623248-3878-3391-F749-696E58B6F0D2}"/>
              </a:ext>
            </a:extLst>
          </p:cNvPr>
          <p:cNvSpPr txBox="1"/>
          <p:nvPr/>
        </p:nvSpPr>
        <p:spPr>
          <a:xfrm>
            <a:off x="232583" y="3499963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56EEE3B-8665-3E8A-05C5-A464F2ECFFA1}"/>
              </a:ext>
            </a:extLst>
          </p:cNvPr>
          <p:cNvSpPr txBox="1"/>
          <p:nvPr/>
        </p:nvSpPr>
        <p:spPr>
          <a:xfrm>
            <a:off x="232583" y="1767114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68AFFF7-C8AB-0973-213F-4A00B1C8CEFB}"/>
              </a:ext>
            </a:extLst>
          </p:cNvPr>
          <p:cNvSpPr txBox="1"/>
          <p:nvPr/>
        </p:nvSpPr>
        <p:spPr>
          <a:xfrm>
            <a:off x="232583" y="2095275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D7CF05E-9B7A-4979-74ED-B7974EE5674D}"/>
              </a:ext>
            </a:extLst>
          </p:cNvPr>
          <p:cNvSpPr txBox="1"/>
          <p:nvPr/>
        </p:nvSpPr>
        <p:spPr>
          <a:xfrm>
            <a:off x="232583" y="3095239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11DB087-D2BD-4AFA-207C-15337B889856}"/>
              </a:ext>
            </a:extLst>
          </p:cNvPr>
          <p:cNvSpPr txBox="1"/>
          <p:nvPr/>
        </p:nvSpPr>
        <p:spPr>
          <a:xfrm>
            <a:off x="232583" y="3282199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06F7711F-DCDD-FCFD-F708-6E34CDC28C70}"/>
              </a:ext>
            </a:extLst>
          </p:cNvPr>
          <p:cNvCxnSpPr/>
          <p:nvPr/>
        </p:nvCxnSpPr>
        <p:spPr>
          <a:xfrm>
            <a:off x="485863" y="97689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C20C3B90-C507-B7C6-D1EF-F46EDD70905A}"/>
              </a:ext>
            </a:extLst>
          </p:cNvPr>
          <p:cNvCxnSpPr/>
          <p:nvPr/>
        </p:nvCxnSpPr>
        <p:spPr>
          <a:xfrm>
            <a:off x="485863" y="143553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5934781A-4D64-233B-D957-43A9EC6234AC}"/>
              </a:ext>
            </a:extLst>
          </p:cNvPr>
          <p:cNvCxnSpPr/>
          <p:nvPr/>
        </p:nvCxnSpPr>
        <p:spPr>
          <a:xfrm>
            <a:off x="485863" y="187848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2728105D-1B67-2536-E3AC-326F85F5B9A5}"/>
              </a:ext>
            </a:extLst>
          </p:cNvPr>
          <p:cNvCxnSpPr/>
          <p:nvPr/>
        </p:nvCxnSpPr>
        <p:spPr>
          <a:xfrm>
            <a:off x="485863" y="221503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BE55856E-9EA1-3120-463D-964FA9A3DD1F}"/>
              </a:ext>
            </a:extLst>
          </p:cNvPr>
          <p:cNvCxnSpPr/>
          <p:nvPr/>
        </p:nvCxnSpPr>
        <p:spPr>
          <a:xfrm>
            <a:off x="485863" y="280240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EA7FB159-6340-0B17-ADEC-6C1B909DA67B}"/>
              </a:ext>
            </a:extLst>
          </p:cNvPr>
          <p:cNvCxnSpPr/>
          <p:nvPr/>
        </p:nvCxnSpPr>
        <p:spPr>
          <a:xfrm>
            <a:off x="485863" y="320880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3A13E9F6-0242-834A-B8DF-472F42E01F4C}"/>
              </a:ext>
            </a:extLst>
          </p:cNvPr>
          <p:cNvCxnSpPr/>
          <p:nvPr/>
        </p:nvCxnSpPr>
        <p:spPr>
          <a:xfrm>
            <a:off x="485863" y="362155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39331165-FDF0-52F4-CB00-2BD47BC825B4}"/>
              </a:ext>
            </a:extLst>
          </p:cNvPr>
          <p:cNvCxnSpPr/>
          <p:nvPr/>
        </p:nvCxnSpPr>
        <p:spPr>
          <a:xfrm>
            <a:off x="490341" y="3394528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3" name="Picture 52">
            <a:extLst>
              <a:ext uri="{FF2B5EF4-FFF2-40B4-BE49-F238E27FC236}">
                <a16:creationId xmlns:a16="http://schemas.microsoft.com/office/drawing/2014/main" id="{4217D99F-DCF1-6948-5CC3-628C795F090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/>
          <a:srcRect l="51535" t="22562" r="22037" b="71095"/>
          <a:stretch/>
        </p:blipFill>
        <p:spPr>
          <a:xfrm>
            <a:off x="567440" y="1279810"/>
            <a:ext cx="1706799" cy="370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F62BC54B-768C-AFDF-765E-C6011A2DC1E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1" t="623" r="278" b="166"/>
          <a:stretch/>
        </p:blipFill>
        <p:spPr>
          <a:xfrm rot="16200000">
            <a:off x="3326389" y="-247179"/>
            <a:ext cx="2394436" cy="31447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EF6F4772-98B8-8023-2E2C-CAD763524E8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/>
          <a:srcRect l="421" t="185" r="-228" b="274"/>
          <a:stretch/>
        </p:blipFill>
        <p:spPr>
          <a:xfrm>
            <a:off x="6185587" y="127995"/>
            <a:ext cx="3638543" cy="24678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E6FF8CB4-E49E-FBFD-F67C-0E305A893B0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" t="167" r="125" b="-37"/>
          <a:stretch/>
        </p:blipFill>
        <p:spPr>
          <a:xfrm rot="16200000">
            <a:off x="3286774" y="2130824"/>
            <a:ext cx="2382755" cy="32904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3829E84C-BD43-F9D8-474E-2F10751FBE8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8" t="419" r="859" b="266"/>
          <a:stretch/>
        </p:blipFill>
        <p:spPr>
          <a:xfrm rot="16200000">
            <a:off x="6582525" y="2068707"/>
            <a:ext cx="2654765" cy="34147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1F74E7C0-9E8F-34CD-F3AE-BEECB1E45F3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7" t="703" r="-505" b="819"/>
          <a:stretch/>
        </p:blipFill>
        <p:spPr>
          <a:xfrm rot="16200000">
            <a:off x="835718" y="3894264"/>
            <a:ext cx="2265895" cy="35545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3215ED05-5A52-2E32-99EB-B3CD4A28AB1D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6" t="515" r="438" b="592"/>
          <a:stretch/>
        </p:blipFill>
        <p:spPr>
          <a:xfrm rot="16200000">
            <a:off x="4185127" y="4207268"/>
            <a:ext cx="2239763" cy="299379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0" name="Rectangle 59">
            <a:extLst>
              <a:ext uri="{FF2B5EF4-FFF2-40B4-BE49-F238E27FC236}">
                <a16:creationId xmlns:a16="http://schemas.microsoft.com/office/drawing/2014/main" id="{C0B6F542-5F53-B633-DB18-543A62DA12A5}"/>
              </a:ext>
            </a:extLst>
          </p:cNvPr>
          <p:cNvSpPr/>
          <p:nvPr/>
        </p:nvSpPr>
        <p:spPr>
          <a:xfrm>
            <a:off x="4482459" y="1328283"/>
            <a:ext cx="905256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96D06F24-F019-D940-29E0-369828D5F4A2}"/>
              </a:ext>
            </a:extLst>
          </p:cNvPr>
          <p:cNvSpPr/>
          <p:nvPr/>
        </p:nvSpPr>
        <p:spPr>
          <a:xfrm>
            <a:off x="7991475" y="639956"/>
            <a:ext cx="1040693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353C102B-FC62-E62B-5B64-67B936932BED}"/>
              </a:ext>
            </a:extLst>
          </p:cNvPr>
          <p:cNvSpPr/>
          <p:nvPr/>
        </p:nvSpPr>
        <p:spPr>
          <a:xfrm>
            <a:off x="4395391" y="3134266"/>
            <a:ext cx="1040693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18131F81-C7BD-77E7-2AF4-067EAB0550FD}"/>
              </a:ext>
            </a:extLst>
          </p:cNvPr>
          <p:cNvSpPr/>
          <p:nvPr/>
        </p:nvSpPr>
        <p:spPr>
          <a:xfrm>
            <a:off x="7764943" y="4029165"/>
            <a:ext cx="1040693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011FEDBB-2713-73E6-83D7-454CB7E2C292}"/>
              </a:ext>
            </a:extLst>
          </p:cNvPr>
          <p:cNvSpPr/>
          <p:nvPr/>
        </p:nvSpPr>
        <p:spPr>
          <a:xfrm>
            <a:off x="1910042" y="5267798"/>
            <a:ext cx="1040693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36DED024-5AB5-6846-5470-63085C9E30DB}"/>
              </a:ext>
            </a:extLst>
          </p:cNvPr>
          <p:cNvSpPr/>
          <p:nvPr/>
        </p:nvSpPr>
        <p:spPr>
          <a:xfrm>
            <a:off x="1935413" y="6028788"/>
            <a:ext cx="1040693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DC9597FC-BA86-D6DA-3F27-90079325CB74}"/>
              </a:ext>
            </a:extLst>
          </p:cNvPr>
          <p:cNvSpPr/>
          <p:nvPr/>
        </p:nvSpPr>
        <p:spPr>
          <a:xfrm>
            <a:off x="5276850" y="6152916"/>
            <a:ext cx="907213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4C043B5-4FEC-ED0F-601A-EF6D67153E8A}"/>
              </a:ext>
            </a:extLst>
          </p:cNvPr>
          <p:cNvSpPr txBox="1"/>
          <p:nvPr/>
        </p:nvSpPr>
        <p:spPr>
          <a:xfrm>
            <a:off x="5332481" y="1348497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96FAA677-F6FC-E8D7-BC72-B6868B11B976}"/>
              </a:ext>
            </a:extLst>
          </p:cNvPr>
          <p:cNvSpPr txBox="1"/>
          <p:nvPr/>
        </p:nvSpPr>
        <p:spPr>
          <a:xfrm>
            <a:off x="9035401" y="623167"/>
            <a:ext cx="491393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2E63FB7-3204-DB18-4BAA-9858B8581263}"/>
              </a:ext>
            </a:extLst>
          </p:cNvPr>
          <p:cNvSpPr txBox="1"/>
          <p:nvPr/>
        </p:nvSpPr>
        <p:spPr>
          <a:xfrm>
            <a:off x="5436084" y="3108219"/>
            <a:ext cx="491393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91CA625-CEF3-D827-4E92-1BAE02C0E953}"/>
              </a:ext>
            </a:extLst>
          </p:cNvPr>
          <p:cNvSpPr txBox="1"/>
          <p:nvPr/>
        </p:nvSpPr>
        <p:spPr>
          <a:xfrm>
            <a:off x="7264485" y="4048609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FDE4BCF-5C8C-DADD-7093-0812D9CB35B7}"/>
              </a:ext>
            </a:extLst>
          </p:cNvPr>
          <p:cNvSpPr txBox="1"/>
          <p:nvPr/>
        </p:nvSpPr>
        <p:spPr>
          <a:xfrm>
            <a:off x="2953716" y="5249178"/>
            <a:ext cx="37189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C7244F6-A75E-3409-EA29-63502902B5A4}"/>
              </a:ext>
            </a:extLst>
          </p:cNvPr>
          <p:cNvSpPr txBox="1"/>
          <p:nvPr/>
        </p:nvSpPr>
        <p:spPr>
          <a:xfrm>
            <a:off x="2966434" y="6017323"/>
            <a:ext cx="44767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743A91C0-CD5D-77E2-4FC1-B661C15A5407}"/>
              </a:ext>
            </a:extLst>
          </p:cNvPr>
          <p:cNvSpPr txBox="1"/>
          <p:nvPr/>
        </p:nvSpPr>
        <p:spPr>
          <a:xfrm>
            <a:off x="6210969" y="6159819"/>
            <a:ext cx="49576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40596762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2ED9333-D826-C915-F203-E30A35A92520}"/>
              </a:ext>
            </a:extLst>
          </p:cNvPr>
          <p:cNvSpPr txBox="1"/>
          <p:nvPr/>
        </p:nvSpPr>
        <p:spPr>
          <a:xfrm>
            <a:off x="232493" y="17619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D5BB4CB-B8FC-C115-F3E8-565D441AABFD}"/>
              </a:ext>
            </a:extLst>
          </p:cNvPr>
          <p:cNvSpPr txBox="1"/>
          <p:nvPr/>
        </p:nvSpPr>
        <p:spPr>
          <a:xfrm>
            <a:off x="1370718" y="276892"/>
            <a:ext cx="618945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KO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0A28743-BF7A-FFA5-3B41-0795D898AE05}"/>
              </a:ext>
            </a:extLst>
          </p:cNvPr>
          <p:cNvSpPr txBox="1"/>
          <p:nvPr/>
        </p:nvSpPr>
        <p:spPr>
          <a:xfrm>
            <a:off x="2158870" y="331801"/>
            <a:ext cx="7374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AFE475A-C111-24C2-4768-C987A4084FEE}"/>
              </a:ext>
            </a:extLst>
          </p:cNvPr>
          <p:cNvSpPr txBox="1"/>
          <p:nvPr/>
        </p:nvSpPr>
        <p:spPr>
          <a:xfrm>
            <a:off x="2185031" y="1416914"/>
            <a:ext cx="4458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8567BA4-F74C-F294-7965-C2AFE9222FA5}"/>
              </a:ext>
            </a:extLst>
          </p:cNvPr>
          <p:cNvSpPr txBox="1"/>
          <p:nvPr/>
        </p:nvSpPr>
        <p:spPr>
          <a:xfrm>
            <a:off x="2185031" y="1795702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65F6E47-3578-8FE4-9D77-DCE1F584C750}"/>
              </a:ext>
            </a:extLst>
          </p:cNvPr>
          <p:cNvSpPr txBox="1"/>
          <p:nvPr/>
        </p:nvSpPr>
        <p:spPr>
          <a:xfrm>
            <a:off x="2185031" y="1074361"/>
            <a:ext cx="5020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41B2A5-A4BE-80BD-EA87-645F90D68BFD}"/>
              </a:ext>
            </a:extLst>
          </p:cNvPr>
          <p:cNvSpPr txBox="1"/>
          <p:nvPr/>
        </p:nvSpPr>
        <p:spPr>
          <a:xfrm>
            <a:off x="1324960" y="470247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2CE6521-6532-F5E7-4877-BBEB0BDFAFAE}"/>
              </a:ext>
            </a:extLst>
          </p:cNvPr>
          <p:cNvSpPr txBox="1"/>
          <p:nvPr/>
        </p:nvSpPr>
        <p:spPr>
          <a:xfrm>
            <a:off x="1429919" y="470247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0F7D38-AF65-B1AB-C275-ABEFE7F9A059}"/>
              </a:ext>
            </a:extLst>
          </p:cNvPr>
          <p:cNvSpPr txBox="1"/>
          <p:nvPr/>
        </p:nvSpPr>
        <p:spPr>
          <a:xfrm>
            <a:off x="1639837" y="470247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B4BCC70-86B2-BB67-A602-3521AC9472AB}"/>
              </a:ext>
            </a:extLst>
          </p:cNvPr>
          <p:cNvSpPr txBox="1"/>
          <p:nvPr/>
        </p:nvSpPr>
        <p:spPr>
          <a:xfrm>
            <a:off x="1958507" y="470247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55BAAC1-10F7-09E3-F2AC-D1E1A4735E5E}"/>
              </a:ext>
            </a:extLst>
          </p:cNvPr>
          <p:cNvSpPr txBox="1"/>
          <p:nvPr/>
        </p:nvSpPr>
        <p:spPr>
          <a:xfrm>
            <a:off x="1534878" y="470247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A0C48D6-B49A-5535-7F16-584C7A3D53C7}"/>
              </a:ext>
            </a:extLst>
          </p:cNvPr>
          <p:cNvSpPr txBox="1"/>
          <p:nvPr/>
        </p:nvSpPr>
        <p:spPr>
          <a:xfrm>
            <a:off x="1799174" y="470247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1FAF611-6B62-48E7-A8C4-1E91BE6D330A}"/>
              </a:ext>
            </a:extLst>
          </p:cNvPr>
          <p:cNvSpPr txBox="1"/>
          <p:nvPr/>
        </p:nvSpPr>
        <p:spPr>
          <a:xfrm>
            <a:off x="532072" y="470247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7091D53-2E7D-70A3-CE8B-96602C00323F}"/>
              </a:ext>
            </a:extLst>
          </p:cNvPr>
          <p:cNvSpPr txBox="1"/>
          <p:nvPr/>
        </p:nvSpPr>
        <p:spPr>
          <a:xfrm>
            <a:off x="637031" y="470247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EF02B52-2625-4442-9A39-264573AA5768}"/>
              </a:ext>
            </a:extLst>
          </p:cNvPr>
          <p:cNvSpPr txBox="1"/>
          <p:nvPr/>
        </p:nvSpPr>
        <p:spPr>
          <a:xfrm>
            <a:off x="846949" y="470247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72AC57E-8B2E-BF93-6145-AF8BD7CA4D51}"/>
              </a:ext>
            </a:extLst>
          </p:cNvPr>
          <p:cNvSpPr txBox="1"/>
          <p:nvPr/>
        </p:nvSpPr>
        <p:spPr>
          <a:xfrm>
            <a:off x="1165623" y="470247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DA6C2E3-1AE4-8B8F-B9D7-6FE6856C7F3E}"/>
              </a:ext>
            </a:extLst>
          </p:cNvPr>
          <p:cNvSpPr txBox="1"/>
          <p:nvPr/>
        </p:nvSpPr>
        <p:spPr>
          <a:xfrm>
            <a:off x="741990" y="470247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235B4FA-4AD8-ED26-7F54-FF50A7339ABA}"/>
              </a:ext>
            </a:extLst>
          </p:cNvPr>
          <p:cNvSpPr txBox="1"/>
          <p:nvPr/>
        </p:nvSpPr>
        <p:spPr>
          <a:xfrm>
            <a:off x="1006286" y="470247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41FD330-0B03-7D1B-5860-ACED10972863}"/>
              </a:ext>
            </a:extLst>
          </p:cNvPr>
          <p:cNvSpPr txBox="1"/>
          <p:nvPr/>
        </p:nvSpPr>
        <p:spPr>
          <a:xfrm>
            <a:off x="736979" y="276893"/>
            <a:ext cx="4599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2AB79FD1-DE8D-2268-7E92-D0870E2EEFA4}"/>
              </a:ext>
            </a:extLst>
          </p:cNvPr>
          <p:cNvCxnSpPr/>
          <p:nvPr/>
        </p:nvCxnSpPr>
        <p:spPr>
          <a:xfrm>
            <a:off x="594516" y="467945"/>
            <a:ext cx="737475" cy="29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9445F1DA-9199-9E89-95E0-6FA88DDA83C0}"/>
              </a:ext>
            </a:extLst>
          </p:cNvPr>
          <p:cNvCxnSpPr/>
          <p:nvPr/>
        </p:nvCxnSpPr>
        <p:spPr>
          <a:xfrm>
            <a:off x="1393317" y="467635"/>
            <a:ext cx="737475" cy="29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709564A7-290E-6831-5C24-D947BB5B4BA3}"/>
              </a:ext>
            </a:extLst>
          </p:cNvPr>
          <p:cNvSpPr txBox="1"/>
          <p:nvPr/>
        </p:nvSpPr>
        <p:spPr>
          <a:xfrm>
            <a:off x="2185031" y="731808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5A077250-46E7-EEFE-65C0-9478D24EEAF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736" t="55464" r="39865" b="16837"/>
          <a:stretch/>
        </p:blipFill>
        <p:spPr>
          <a:xfrm rot="16200000">
            <a:off x="1225013" y="753724"/>
            <a:ext cx="316334" cy="16256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3898DDE-9433-CD91-9218-56928101ABC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818" t="13985" r="49783" b="58316"/>
          <a:stretch/>
        </p:blipFill>
        <p:spPr>
          <a:xfrm rot="16200000">
            <a:off x="1225013" y="386086"/>
            <a:ext cx="316334" cy="16256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7DFEFA82-2033-0A51-49F6-90C47F21810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224" t="15809" r="28847" b="55520"/>
          <a:stretch/>
        </p:blipFill>
        <p:spPr>
          <a:xfrm rot="16200000">
            <a:off x="1225013" y="18449"/>
            <a:ext cx="316334" cy="16256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596BCC41-BC0D-5888-42CB-FFA4FB73939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000" t="16199" r="45047" b="56185"/>
          <a:stretch/>
        </p:blipFill>
        <p:spPr>
          <a:xfrm rot="16200000">
            <a:off x="1225013" y="1121362"/>
            <a:ext cx="316334" cy="16256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TextBox 16">
            <a:extLst>
              <a:ext uri="{FF2B5EF4-FFF2-40B4-BE49-F238E27FC236}">
                <a16:creationId xmlns:a16="http://schemas.microsoft.com/office/drawing/2014/main" id="{77534DEB-5B44-FD65-1334-93D4723D968C}"/>
              </a:ext>
            </a:extLst>
          </p:cNvPr>
          <p:cNvSpPr txBox="1"/>
          <p:nvPr/>
        </p:nvSpPr>
        <p:spPr>
          <a:xfrm>
            <a:off x="505972" y="2105490"/>
            <a:ext cx="14093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USP43 null clon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EEBC82B-744D-C542-B536-B7F8E58290B9}"/>
              </a:ext>
            </a:extLst>
          </p:cNvPr>
          <p:cNvSpPr txBox="1"/>
          <p:nvPr/>
        </p:nvSpPr>
        <p:spPr>
          <a:xfrm>
            <a:off x="164482" y="480612"/>
            <a:ext cx="32219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99ACDD9-E9B1-7045-95C3-B9A84C9A6461}"/>
              </a:ext>
            </a:extLst>
          </p:cNvPr>
          <p:cNvSpPr txBox="1"/>
          <p:nvPr/>
        </p:nvSpPr>
        <p:spPr>
          <a:xfrm>
            <a:off x="171401" y="669361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333A80E-EBD3-CA39-A2FB-AE67A10D9675}"/>
              </a:ext>
            </a:extLst>
          </p:cNvPr>
          <p:cNvSpPr txBox="1"/>
          <p:nvPr/>
        </p:nvSpPr>
        <p:spPr>
          <a:xfrm>
            <a:off x="219576" y="1103562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0AFBEC4-530E-429E-FD51-10AC47B70E45}"/>
              </a:ext>
            </a:extLst>
          </p:cNvPr>
          <p:cNvSpPr txBox="1"/>
          <p:nvPr/>
        </p:nvSpPr>
        <p:spPr>
          <a:xfrm>
            <a:off x="219576" y="1919411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1D040BC-D33E-48CB-B366-C6E02CB0F7F7}"/>
              </a:ext>
            </a:extLst>
          </p:cNvPr>
          <p:cNvSpPr txBox="1"/>
          <p:nvPr/>
        </p:nvSpPr>
        <p:spPr>
          <a:xfrm>
            <a:off x="219576" y="1555597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8A8B5A9D-4E57-3E0F-E8E3-0E78EC0B77EB}"/>
              </a:ext>
            </a:extLst>
          </p:cNvPr>
          <p:cNvCxnSpPr/>
          <p:nvPr/>
        </p:nvCxnSpPr>
        <p:spPr>
          <a:xfrm>
            <a:off x="472856" y="786989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50B6EB1D-473D-3816-41AD-856D135ACB3F}"/>
              </a:ext>
            </a:extLst>
          </p:cNvPr>
          <p:cNvCxnSpPr/>
          <p:nvPr/>
        </p:nvCxnSpPr>
        <p:spPr>
          <a:xfrm>
            <a:off x="472856" y="121388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116764D6-3AF1-7674-BB7B-E1C979359BEC}"/>
              </a:ext>
            </a:extLst>
          </p:cNvPr>
          <p:cNvCxnSpPr/>
          <p:nvPr/>
        </p:nvCxnSpPr>
        <p:spPr>
          <a:xfrm>
            <a:off x="472856" y="204100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774543DD-EDAE-E275-FED8-6752A2A37414}"/>
              </a:ext>
            </a:extLst>
          </p:cNvPr>
          <p:cNvCxnSpPr/>
          <p:nvPr/>
        </p:nvCxnSpPr>
        <p:spPr>
          <a:xfrm>
            <a:off x="477334" y="166792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8" name="Picture 37">
            <a:extLst>
              <a:ext uri="{FF2B5EF4-FFF2-40B4-BE49-F238E27FC236}">
                <a16:creationId xmlns:a16="http://schemas.microsoft.com/office/drawing/2014/main" id="{6CA53BE3-D1DD-89E7-8F4B-7772A10715C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2" t="409" r="-688" b="504"/>
          <a:stretch/>
        </p:blipFill>
        <p:spPr>
          <a:xfrm rot="16200000">
            <a:off x="3435523" y="-108679"/>
            <a:ext cx="2601687" cy="31714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46958354-9AAD-3174-D9CD-8D993C8CC65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7" t="49" r="577" b="-19"/>
          <a:stretch/>
        </p:blipFill>
        <p:spPr>
          <a:xfrm rot="16200000">
            <a:off x="6413310" y="120039"/>
            <a:ext cx="3256859" cy="33119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11167642-517B-CD88-B34B-460D503A901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8" t="467" r="859" b="928"/>
          <a:stretch/>
        </p:blipFill>
        <p:spPr>
          <a:xfrm rot="16200000">
            <a:off x="3120508" y="3432584"/>
            <a:ext cx="3231715" cy="32667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308706A5-710E-3B45-5E51-0AD5CC5D693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" t="363" r="-583" b="452"/>
          <a:stretch/>
        </p:blipFill>
        <p:spPr>
          <a:xfrm rot="16200000">
            <a:off x="6548079" y="3310495"/>
            <a:ext cx="3016678" cy="32958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Rectangle 41">
            <a:extLst>
              <a:ext uri="{FF2B5EF4-FFF2-40B4-BE49-F238E27FC236}">
                <a16:creationId xmlns:a16="http://schemas.microsoft.com/office/drawing/2014/main" id="{AB0E3762-0741-9057-67B8-2DF1ADF327B8}"/>
              </a:ext>
            </a:extLst>
          </p:cNvPr>
          <p:cNvSpPr/>
          <p:nvPr/>
        </p:nvSpPr>
        <p:spPr>
          <a:xfrm>
            <a:off x="3613861" y="915623"/>
            <a:ext cx="905256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B2DFC117-AACC-569B-A003-56495E8BF3B8}"/>
              </a:ext>
            </a:extLst>
          </p:cNvPr>
          <p:cNvSpPr/>
          <p:nvPr/>
        </p:nvSpPr>
        <p:spPr>
          <a:xfrm>
            <a:off x="6854034" y="1724734"/>
            <a:ext cx="905256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17CF0B3B-541F-FA2B-A888-2B1AF7064682}"/>
              </a:ext>
            </a:extLst>
          </p:cNvPr>
          <p:cNvSpPr/>
          <p:nvPr/>
        </p:nvSpPr>
        <p:spPr>
          <a:xfrm>
            <a:off x="4949034" y="4708151"/>
            <a:ext cx="905256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6C7781DE-1B70-7086-D201-200C01F2903D}"/>
              </a:ext>
            </a:extLst>
          </p:cNvPr>
          <p:cNvSpPr/>
          <p:nvPr/>
        </p:nvSpPr>
        <p:spPr>
          <a:xfrm>
            <a:off x="6939759" y="4815670"/>
            <a:ext cx="905256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488D22B-8DA9-23D2-3F6C-881AD6F0D14F}"/>
              </a:ext>
            </a:extLst>
          </p:cNvPr>
          <p:cNvSpPr txBox="1"/>
          <p:nvPr/>
        </p:nvSpPr>
        <p:spPr>
          <a:xfrm>
            <a:off x="4498646" y="925345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4DC86DB-7C16-EBB1-661A-98D6CBDCDAB8}"/>
              </a:ext>
            </a:extLst>
          </p:cNvPr>
          <p:cNvSpPr txBox="1"/>
          <p:nvPr/>
        </p:nvSpPr>
        <p:spPr>
          <a:xfrm>
            <a:off x="7772297" y="1721837"/>
            <a:ext cx="5020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119427D-24C2-C055-043E-EB939964B2FE}"/>
              </a:ext>
            </a:extLst>
          </p:cNvPr>
          <p:cNvSpPr txBox="1"/>
          <p:nvPr/>
        </p:nvSpPr>
        <p:spPr>
          <a:xfrm>
            <a:off x="5848247" y="4727595"/>
            <a:ext cx="4458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C630674-1893-F8DC-F292-0C8BB50B1654}"/>
              </a:ext>
            </a:extLst>
          </p:cNvPr>
          <p:cNvSpPr txBox="1"/>
          <p:nvPr/>
        </p:nvSpPr>
        <p:spPr>
          <a:xfrm>
            <a:off x="6332859" y="4825392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36349923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13594B3-C421-260C-25C8-2129B4B89E7B}"/>
              </a:ext>
            </a:extLst>
          </p:cNvPr>
          <p:cNvSpPr txBox="1"/>
          <p:nvPr/>
        </p:nvSpPr>
        <p:spPr>
          <a:xfrm>
            <a:off x="117251" y="7158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FA9A322-D6C1-C52D-7ECB-B284C521D0B2}"/>
              </a:ext>
            </a:extLst>
          </p:cNvPr>
          <p:cNvSpPr txBox="1"/>
          <p:nvPr/>
        </p:nvSpPr>
        <p:spPr>
          <a:xfrm>
            <a:off x="1312274" y="222587"/>
            <a:ext cx="618945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KO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FC2CF44-41F9-EEA8-2DB7-3514C28095A1}"/>
              </a:ext>
            </a:extLst>
          </p:cNvPr>
          <p:cNvSpPr txBox="1"/>
          <p:nvPr/>
        </p:nvSpPr>
        <p:spPr>
          <a:xfrm>
            <a:off x="2100426" y="277496"/>
            <a:ext cx="7374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BC25F70-614E-7A64-A759-74AD75EF7735}"/>
              </a:ext>
            </a:extLst>
          </p:cNvPr>
          <p:cNvSpPr txBox="1"/>
          <p:nvPr/>
        </p:nvSpPr>
        <p:spPr>
          <a:xfrm>
            <a:off x="2126587" y="1758849"/>
            <a:ext cx="4458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54C2F57-9405-6B8A-1ED5-C533EF9B419E}"/>
              </a:ext>
            </a:extLst>
          </p:cNvPr>
          <p:cNvSpPr txBox="1"/>
          <p:nvPr/>
        </p:nvSpPr>
        <p:spPr>
          <a:xfrm>
            <a:off x="2126587" y="2137637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693C5BE-E903-7138-9162-743F221A316D}"/>
              </a:ext>
            </a:extLst>
          </p:cNvPr>
          <p:cNvSpPr txBox="1"/>
          <p:nvPr/>
        </p:nvSpPr>
        <p:spPr>
          <a:xfrm>
            <a:off x="2126587" y="1020056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35A5500-98EB-D52F-1DEA-ABC89314A5F6}"/>
              </a:ext>
            </a:extLst>
          </p:cNvPr>
          <p:cNvSpPr txBox="1"/>
          <p:nvPr/>
        </p:nvSpPr>
        <p:spPr>
          <a:xfrm>
            <a:off x="1266516" y="415942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AAA4AF5-FB30-D54E-EEA2-FA0ECFD3859C}"/>
              </a:ext>
            </a:extLst>
          </p:cNvPr>
          <p:cNvSpPr txBox="1"/>
          <p:nvPr/>
        </p:nvSpPr>
        <p:spPr>
          <a:xfrm>
            <a:off x="1371475" y="415942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B650533-C794-95E7-3D06-895CBF43B8C6}"/>
              </a:ext>
            </a:extLst>
          </p:cNvPr>
          <p:cNvSpPr txBox="1"/>
          <p:nvPr/>
        </p:nvSpPr>
        <p:spPr>
          <a:xfrm>
            <a:off x="1581393" y="415942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71E1139-CAC1-0C09-9046-47150022470D}"/>
              </a:ext>
            </a:extLst>
          </p:cNvPr>
          <p:cNvSpPr txBox="1"/>
          <p:nvPr/>
        </p:nvSpPr>
        <p:spPr>
          <a:xfrm>
            <a:off x="1900063" y="415942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6348AF8-6558-462F-D293-51B14FFB217D}"/>
              </a:ext>
            </a:extLst>
          </p:cNvPr>
          <p:cNvSpPr txBox="1"/>
          <p:nvPr/>
        </p:nvSpPr>
        <p:spPr>
          <a:xfrm>
            <a:off x="1476434" y="415942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9B90F7F-7FD7-5D71-CBF9-DB1D293BC1CD}"/>
              </a:ext>
            </a:extLst>
          </p:cNvPr>
          <p:cNvSpPr txBox="1"/>
          <p:nvPr/>
        </p:nvSpPr>
        <p:spPr>
          <a:xfrm>
            <a:off x="1740730" y="415942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66896F9-4BC9-B794-5F3E-9FFFF9EF9B65}"/>
              </a:ext>
            </a:extLst>
          </p:cNvPr>
          <p:cNvSpPr txBox="1"/>
          <p:nvPr/>
        </p:nvSpPr>
        <p:spPr>
          <a:xfrm>
            <a:off x="473628" y="415942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3BD6071-8F86-71F4-ABA8-6D5311AD52E1}"/>
              </a:ext>
            </a:extLst>
          </p:cNvPr>
          <p:cNvSpPr txBox="1"/>
          <p:nvPr/>
        </p:nvSpPr>
        <p:spPr>
          <a:xfrm>
            <a:off x="578587" y="415942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A2429FA-1FC7-824A-828E-F1EC1AFC426C}"/>
              </a:ext>
            </a:extLst>
          </p:cNvPr>
          <p:cNvSpPr txBox="1"/>
          <p:nvPr/>
        </p:nvSpPr>
        <p:spPr>
          <a:xfrm>
            <a:off x="788505" y="415942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3317FB9-2927-BAE9-81B8-8AF2150A3DC7}"/>
              </a:ext>
            </a:extLst>
          </p:cNvPr>
          <p:cNvSpPr txBox="1"/>
          <p:nvPr/>
        </p:nvSpPr>
        <p:spPr>
          <a:xfrm>
            <a:off x="1107179" y="415942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0D4901A-9249-73C9-1912-DF8B26B9BC2B}"/>
              </a:ext>
            </a:extLst>
          </p:cNvPr>
          <p:cNvSpPr txBox="1"/>
          <p:nvPr/>
        </p:nvSpPr>
        <p:spPr>
          <a:xfrm>
            <a:off x="683546" y="415942"/>
            <a:ext cx="210992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1DDBA47-787F-E951-5AE3-538503FD96C7}"/>
              </a:ext>
            </a:extLst>
          </p:cNvPr>
          <p:cNvSpPr txBox="1"/>
          <p:nvPr/>
        </p:nvSpPr>
        <p:spPr>
          <a:xfrm>
            <a:off x="947842" y="415942"/>
            <a:ext cx="2653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259D809-C86D-DF85-4054-8606DB201E55}"/>
              </a:ext>
            </a:extLst>
          </p:cNvPr>
          <p:cNvSpPr txBox="1"/>
          <p:nvPr/>
        </p:nvSpPr>
        <p:spPr>
          <a:xfrm>
            <a:off x="678535" y="222588"/>
            <a:ext cx="459970" cy="197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B659E29F-5AE2-035A-92FA-795F59CB162E}"/>
              </a:ext>
            </a:extLst>
          </p:cNvPr>
          <p:cNvCxnSpPr/>
          <p:nvPr/>
        </p:nvCxnSpPr>
        <p:spPr>
          <a:xfrm>
            <a:off x="536072" y="413640"/>
            <a:ext cx="737475" cy="29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B58CD388-DB4F-795B-4C52-62F0E3E752D4}"/>
              </a:ext>
            </a:extLst>
          </p:cNvPr>
          <p:cNvCxnSpPr/>
          <p:nvPr/>
        </p:nvCxnSpPr>
        <p:spPr>
          <a:xfrm>
            <a:off x="1334873" y="413330"/>
            <a:ext cx="737475" cy="29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994E44CE-221C-168F-87F8-59EAAE113D99}"/>
              </a:ext>
            </a:extLst>
          </p:cNvPr>
          <p:cNvSpPr txBox="1"/>
          <p:nvPr/>
        </p:nvSpPr>
        <p:spPr>
          <a:xfrm>
            <a:off x="2126587" y="677503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4" name="TextBox 16">
            <a:extLst>
              <a:ext uri="{FF2B5EF4-FFF2-40B4-BE49-F238E27FC236}">
                <a16:creationId xmlns:a16="http://schemas.microsoft.com/office/drawing/2014/main" id="{8E9947C1-9CEC-2270-7695-76EC8D8C0C54}"/>
              </a:ext>
            </a:extLst>
          </p:cNvPr>
          <p:cNvSpPr txBox="1"/>
          <p:nvPr/>
        </p:nvSpPr>
        <p:spPr>
          <a:xfrm>
            <a:off x="497594" y="2361662"/>
            <a:ext cx="14029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549 USP43 null clon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DB7AA6B-01F2-8BDB-54D6-14FDD4E09E7C}"/>
              </a:ext>
            </a:extLst>
          </p:cNvPr>
          <p:cNvSpPr txBox="1"/>
          <p:nvPr/>
        </p:nvSpPr>
        <p:spPr>
          <a:xfrm>
            <a:off x="131438" y="426307"/>
            <a:ext cx="32219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673B34B4-E1AC-69DE-12EE-7D5F4EC4E3C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87" t="18885" r="65411" b="54313"/>
          <a:stretch/>
        </p:blipFill>
        <p:spPr>
          <a:xfrm rot="5400000">
            <a:off x="1193282" y="678671"/>
            <a:ext cx="304816" cy="16256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4DDC8ABF-2183-12F5-3964-942A5620CF5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41" t="18666" r="55857" b="54532"/>
          <a:stretch/>
        </p:blipFill>
        <p:spPr>
          <a:xfrm rot="5400000">
            <a:off x="1193282" y="1038537"/>
            <a:ext cx="304816" cy="16256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DC5D21E7-A151-EF62-F819-8461B6004BF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487" t="18358" r="49808" b="54427"/>
          <a:stretch/>
        </p:blipFill>
        <p:spPr>
          <a:xfrm rot="5400000">
            <a:off x="1193282" y="1398405"/>
            <a:ext cx="304816" cy="16256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91587A6E-995C-F5B0-1390-975AC950E61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81" t="56326" r="36388" b="17224"/>
          <a:stretch/>
        </p:blipFill>
        <p:spPr>
          <a:xfrm rot="5400000">
            <a:off x="1193282" y="318804"/>
            <a:ext cx="304816" cy="16256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586A6BFD-26E5-1492-A83C-DDDA24B3944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84" t="21076" r="64896" b="53552"/>
          <a:stretch/>
        </p:blipFill>
        <p:spPr>
          <a:xfrm rot="5400000">
            <a:off x="1194298" y="-38008"/>
            <a:ext cx="302784" cy="16256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6C308BB5-9E34-3E5D-2DB4-D4C8FD48FA95}"/>
              </a:ext>
            </a:extLst>
          </p:cNvPr>
          <p:cNvSpPr txBox="1"/>
          <p:nvPr/>
        </p:nvSpPr>
        <p:spPr>
          <a:xfrm>
            <a:off x="2126587" y="1407570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2AA1626-2F9A-F8A4-4F31-5DE82FEDCFE9}"/>
              </a:ext>
            </a:extLst>
          </p:cNvPr>
          <p:cNvSpPr txBox="1"/>
          <p:nvPr/>
        </p:nvSpPr>
        <p:spPr>
          <a:xfrm>
            <a:off x="137284" y="627442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56BC392-B6CD-ADF6-8D95-575CC6A81372}"/>
              </a:ext>
            </a:extLst>
          </p:cNvPr>
          <p:cNvSpPr txBox="1"/>
          <p:nvPr/>
        </p:nvSpPr>
        <p:spPr>
          <a:xfrm>
            <a:off x="185459" y="985443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A69C41F-D862-2BE0-C802-F138E574154B}"/>
              </a:ext>
            </a:extLst>
          </p:cNvPr>
          <p:cNvSpPr txBox="1"/>
          <p:nvPr/>
        </p:nvSpPr>
        <p:spPr>
          <a:xfrm>
            <a:off x="185459" y="2087042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F0D0166-ACC3-E800-6D4E-E910E9CA9BE8}"/>
              </a:ext>
            </a:extLst>
          </p:cNvPr>
          <p:cNvSpPr txBox="1"/>
          <p:nvPr/>
        </p:nvSpPr>
        <p:spPr>
          <a:xfrm>
            <a:off x="185459" y="1341618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1DC6A3B-9E78-9F69-6810-DB38A0CCC720}"/>
              </a:ext>
            </a:extLst>
          </p:cNvPr>
          <p:cNvSpPr txBox="1"/>
          <p:nvPr/>
        </p:nvSpPr>
        <p:spPr>
          <a:xfrm>
            <a:off x="185459" y="1831178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C8033FE7-F8A2-F6D6-9E3F-C5A16777F4AC}"/>
              </a:ext>
            </a:extLst>
          </p:cNvPr>
          <p:cNvCxnSpPr/>
          <p:nvPr/>
        </p:nvCxnSpPr>
        <p:spPr>
          <a:xfrm>
            <a:off x="438739" y="74507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47FEB006-8376-F7FC-579A-D520A8AA0DF2}"/>
              </a:ext>
            </a:extLst>
          </p:cNvPr>
          <p:cNvCxnSpPr/>
          <p:nvPr/>
        </p:nvCxnSpPr>
        <p:spPr>
          <a:xfrm>
            <a:off x="438739" y="109576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0CA67B31-96DE-1E16-1587-E54F5DA3A65D}"/>
              </a:ext>
            </a:extLst>
          </p:cNvPr>
          <p:cNvCxnSpPr/>
          <p:nvPr/>
        </p:nvCxnSpPr>
        <p:spPr>
          <a:xfrm>
            <a:off x="438739" y="145298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AA6BCED-F50D-4E91-75B2-8919F1957C15}"/>
              </a:ext>
            </a:extLst>
          </p:cNvPr>
          <p:cNvCxnSpPr/>
          <p:nvPr/>
        </p:nvCxnSpPr>
        <p:spPr>
          <a:xfrm>
            <a:off x="438739" y="220863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573708F3-819D-2FE8-D8FA-F1964EAB5EAE}"/>
              </a:ext>
            </a:extLst>
          </p:cNvPr>
          <p:cNvCxnSpPr/>
          <p:nvPr/>
        </p:nvCxnSpPr>
        <p:spPr>
          <a:xfrm>
            <a:off x="443217" y="1943507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2" name="Picture 41">
            <a:extLst>
              <a:ext uri="{FF2B5EF4-FFF2-40B4-BE49-F238E27FC236}">
                <a16:creationId xmlns:a16="http://schemas.microsoft.com/office/drawing/2014/main" id="{B2DE5B1A-50D9-7D9F-6B80-C10B7933FF7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75" t="206" r="-461" b="230"/>
          <a:stretch/>
        </p:blipFill>
        <p:spPr>
          <a:xfrm rot="5400000">
            <a:off x="3704614" y="-549640"/>
            <a:ext cx="2206043" cy="36010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341BC82E-8C03-2BBD-C602-95BD922924A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" t="321" r="800" b="805"/>
          <a:stretch/>
        </p:blipFill>
        <p:spPr>
          <a:xfrm rot="5400000">
            <a:off x="7242809" y="-307571"/>
            <a:ext cx="2516257" cy="34302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3A0FCF96-61A3-A098-7D0E-CC96B29E2F8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" t="-78" r="1267" b="460"/>
          <a:stretch/>
        </p:blipFill>
        <p:spPr>
          <a:xfrm rot="5400000">
            <a:off x="594406" y="2274894"/>
            <a:ext cx="2456395" cy="34107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B6256250-6CFD-541E-B692-46C84394CDF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2" t="-377" r="502" b="-257"/>
          <a:stretch/>
        </p:blipFill>
        <p:spPr>
          <a:xfrm rot="5400000">
            <a:off x="4078496" y="2360033"/>
            <a:ext cx="2559770" cy="33932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7" name="Rectangle 46">
            <a:extLst>
              <a:ext uri="{FF2B5EF4-FFF2-40B4-BE49-F238E27FC236}">
                <a16:creationId xmlns:a16="http://schemas.microsoft.com/office/drawing/2014/main" id="{6DC2776E-BFE8-D3DD-C023-17D33CF4737D}"/>
              </a:ext>
            </a:extLst>
          </p:cNvPr>
          <p:cNvSpPr/>
          <p:nvPr/>
        </p:nvSpPr>
        <p:spPr>
          <a:xfrm>
            <a:off x="4905752" y="745070"/>
            <a:ext cx="1190247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F81BA6AB-8C34-AEFD-9FB8-2EA528264F3E}"/>
              </a:ext>
            </a:extLst>
          </p:cNvPr>
          <p:cNvSpPr/>
          <p:nvPr/>
        </p:nvSpPr>
        <p:spPr>
          <a:xfrm>
            <a:off x="7310691" y="1553681"/>
            <a:ext cx="1014160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80478A2E-4A94-B067-21C1-AB6BAEDE25CD}"/>
              </a:ext>
            </a:extLst>
          </p:cNvPr>
          <p:cNvSpPr/>
          <p:nvPr/>
        </p:nvSpPr>
        <p:spPr>
          <a:xfrm>
            <a:off x="1934632" y="3402638"/>
            <a:ext cx="1014160" cy="2502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91023F0D-C7E2-4787-FDCB-86C078D91AC9}"/>
              </a:ext>
            </a:extLst>
          </p:cNvPr>
          <p:cNvSpPr/>
          <p:nvPr/>
        </p:nvSpPr>
        <p:spPr>
          <a:xfrm>
            <a:off x="1931219" y="3687523"/>
            <a:ext cx="1014160" cy="1631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7A3913F1-2249-B283-6B45-09E41D565727}"/>
              </a:ext>
            </a:extLst>
          </p:cNvPr>
          <p:cNvSpPr/>
          <p:nvPr/>
        </p:nvSpPr>
        <p:spPr>
          <a:xfrm>
            <a:off x="5443557" y="3878825"/>
            <a:ext cx="1014160" cy="197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9A592B4-CDCB-C2DF-4F11-06829B80155D}"/>
              </a:ext>
            </a:extLst>
          </p:cNvPr>
          <p:cNvSpPr txBox="1"/>
          <p:nvPr/>
        </p:nvSpPr>
        <p:spPr>
          <a:xfrm>
            <a:off x="6095999" y="754792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818847E-487A-94E2-6796-B77060EF5F18}"/>
              </a:ext>
            </a:extLst>
          </p:cNvPr>
          <p:cNvSpPr txBox="1"/>
          <p:nvPr/>
        </p:nvSpPr>
        <p:spPr>
          <a:xfrm>
            <a:off x="8324851" y="1553681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FDF5ADE-82E9-6252-896A-E1A2E8F74E5B}"/>
              </a:ext>
            </a:extLst>
          </p:cNvPr>
          <p:cNvSpPr txBox="1"/>
          <p:nvPr/>
        </p:nvSpPr>
        <p:spPr>
          <a:xfrm>
            <a:off x="2945379" y="3252613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74F6E5C-1277-6B85-83E6-FAB5A8B518FA}"/>
              </a:ext>
            </a:extLst>
          </p:cNvPr>
          <p:cNvSpPr txBox="1"/>
          <p:nvPr/>
        </p:nvSpPr>
        <p:spPr>
          <a:xfrm>
            <a:off x="1586893" y="3644717"/>
            <a:ext cx="4458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5BC920E-93BD-F9D8-6C59-7C9C0F9CF69B}"/>
              </a:ext>
            </a:extLst>
          </p:cNvPr>
          <p:cNvSpPr txBox="1"/>
          <p:nvPr/>
        </p:nvSpPr>
        <p:spPr>
          <a:xfrm>
            <a:off x="6481709" y="3822227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2362179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95</Words>
  <Application>Microsoft Office PowerPoint</Application>
  <PresentationFormat>Widescreen</PresentationFormat>
  <Paragraphs>14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2</cp:revision>
  <dcterms:created xsi:type="dcterms:W3CDTF">2024-05-20T07:40:06Z</dcterms:created>
  <dcterms:modified xsi:type="dcterms:W3CDTF">2024-05-20T07:56:53Z</dcterms:modified>
</cp:coreProperties>
</file>